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8FC98-B0FD-4D4C-ABDF-07A9F6774A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AD0F4F-ED34-4CBF-85EA-45FE31DD6F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DF525-06FC-424F-8689-7C429916ED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BC84B-1D86-44C3-B7F0-68CAE423CD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FF1E7-2A45-459B-853D-FEBE6FBB53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79FDA-C6DE-4AFF-954B-CA1E67D325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5162DF-730B-40D1-B290-0BCD383BC3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CDB76D-5A65-4697-B1F1-4C801ABA2F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AB7554-32EE-430E-9683-323E6A452A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3DE4A-89B3-4899-9729-EAC458096F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B4E71-41F4-453F-8A7C-EDB57EA0D8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2BA8B-2499-4A30-ACED-B652E5B22E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BDC5D5-1535-410D-A740-5B3FC1B111D1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08000" y="928800"/>
          <a:ext cx="4608720" cy="5435640"/>
        </p:xfrm>
        <a:graphic>
          <a:graphicData uri="http://schemas.openxmlformats.org/drawingml/2006/table">
            <a:tbl>
              <a:tblPr/>
              <a:tblGrid>
                <a:gridCol w="2592720"/>
                <a:gridCol w="2016000"/>
              </a:tblGrid>
              <a:tr h="339480">
                <a:tc>
                  <a:txBody>
                    <a:bodyPr lIns="9360" rIns="936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Combinati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Percentage %</a:t>
                      </a:r>
                      <a:r>
                        <a:rPr b="1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(n=107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Vibri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.1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AE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3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48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S. typhimurium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3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C. jejun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3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TE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7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48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C. difficile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Rotaviru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7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C. jejuni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C. difficil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Rotaviru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48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T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AE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A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S. typhimurium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. coli-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O15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Norovirus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Vitri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48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PEC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S. typhimurium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Vitri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S. typhimurium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+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 </a:t>
                      </a: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C. jejun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360" rIns="936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DengXian"/>
                        </a:rPr>
                        <a:t>ETEC+EAE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mr-I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文本框 4"/>
          <p:cNvSpPr/>
          <p:nvPr/>
        </p:nvSpPr>
        <p:spPr>
          <a:xfrm>
            <a:off x="69840" y="214200"/>
            <a:ext cx="7359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3. Frequency of the combinations of polymicrobial infectio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1-30T03:32:46Z</dcterms:created>
  <dc:creator>pc</dc:creator>
  <dc:description/>
  <dc:language>en-US</dc:language>
  <cp:lastModifiedBy>zhaohu</cp:lastModifiedBy>
  <dcterms:modified xsi:type="dcterms:W3CDTF">2018-07-21T06:52:01Z</dcterms:modified>
  <cp:revision>4</cp:revision>
  <dc:subject/>
  <dc:title>幻灯片 1</dc:title>
</cp:coreProperties>
</file>